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62" r:id="rId3"/>
    <p:sldId id="260" r:id="rId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84043" autoAdjust="0"/>
  </p:normalViewPr>
  <p:slideViewPr>
    <p:cSldViewPr snapToGrid="0">
      <p:cViewPr varScale="1">
        <p:scale>
          <a:sx n="92" d="100"/>
          <a:sy n="92" d="100"/>
        </p:scale>
        <p:origin x="125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9BCF9CE-4B52-4286-AD28-6D513DA3945D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E55E32-DF5C-4C49-9FB6-7447EEDB8C9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96841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DE55E32-DF5C-4C49-9FB6-7447EEDB8C92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8066303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b="1" dirty="0">
                <a:latin typeface="TIMES" panose="02020603050405020304" pitchFamily="18" charset="0"/>
                <a:cs typeface="TIMES" panose="02020603050405020304" pitchFamily="18" charset="0"/>
              </a:rPr>
              <a:t>  </a:t>
            </a:r>
            <a:endParaRPr lang="ko-KR" altLang="en-US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DE55E32-DF5C-4C49-9FB6-7447EEDB8C92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0831432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DE55E32-DF5C-4C49-9FB6-7447EEDB8C92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449739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61EB7FD-FEED-4FF3-9CCF-0A8C08258F5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FF68B363-957E-4D6A-8D18-8B9297788D0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11" indent="0" algn="ctr">
              <a:buNone/>
              <a:defRPr sz="2000"/>
            </a:lvl2pPr>
            <a:lvl3pPr marL="914422" indent="0" algn="ctr">
              <a:buNone/>
              <a:defRPr sz="1801"/>
            </a:lvl3pPr>
            <a:lvl4pPr marL="1371635" indent="0" algn="ctr">
              <a:buNone/>
              <a:defRPr sz="1600"/>
            </a:lvl4pPr>
            <a:lvl5pPr marL="1828846" indent="0" algn="ctr">
              <a:buNone/>
              <a:defRPr sz="1600"/>
            </a:lvl5pPr>
            <a:lvl6pPr marL="2286057" indent="0" algn="ctr">
              <a:buNone/>
              <a:defRPr sz="1600"/>
            </a:lvl6pPr>
            <a:lvl7pPr marL="2743268" indent="0" algn="ctr">
              <a:buNone/>
              <a:defRPr sz="1600"/>
            </a:lvl7pPr>
            <a:lvl8pPr marL="3200481" indent="0" algn="ctr">
              <a:buNone/>
              <a:defRPr sz="1600"/>
            </a:lvl8pPr>
            <a:lvl9pPr marL="3657692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23DDB01-2D05-4861-90B8-CDD965DAE2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6E50A-900A-42D8-9AC2-0BDD1A2E026D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C34CF17-FD9D-47E1-9715-14B6E48811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A84AC46-B4C6-4C80-9D10-A06702DDF1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E98E7-7B45-4A9A-9418-C7BA6C4525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723648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E4471BC-A70A-496E-9C5C-BC5F045C2B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DF6A1C56-9600-4AF9-B294-FF7A41FB3A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587950C-867C-48C4-BBC0-21DBD624DF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6E50A-900A-42D8-9AC2-0BDD1A2E026D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73BFF5B-3B2A-499E-B9FC-401FB90726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D24815E-C20A-48C2-A5B1-E338D08EF6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E98E7-7B45-4A9A-9418-C7BA6C4525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324888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8D246ADA-AFBC-4D5F-8D00-B9B7B1462F7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925EB166-F88B-4D56-B535-7F12DAA076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AC9F89F-20D0-4696-805F-24D06563E4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6E50A-900A-42D8-9AC2-0BDD1A2E026D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4CBB0DD-DD04-4EDF-B828-C0EF7D2964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22FB179-7A31-4AFD-8D66-082D089EE2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E98E7-7B45-4A9A-9418-C7BA6C4525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90344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C10DE5E-3941-499B-B3BB-A290F2330D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97EAEFB-6EE0-4D76-8216-924251543ED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6325292-9481-4598-BC57-2DB704AA2E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6E50A-900A-42D8-9AC2-0BDD1A2E026D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08CBD6B-E386-43B6-98A2-FB39CC721B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3FBC59C-F67A-4723-9A3F-551695AAC8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E98E7-7B45-4A9A-9418-C7BA6C4525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74629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755779B-7CD7-4005-B821-90581B35DB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3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620DADA-6418-43FA-85C1-F4C455CAD0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3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1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22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63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5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6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8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9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4A70FC1-C233-490E-B31E-82ADED09B8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6E50A-900A-42D8-9AC2-0BDD1A2E026D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AD92307-FDC5-4C4A-93EE-631D8992A3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B7B888E-6D94-43FB-8367-39775C24FC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E98E7-7B45-4A9A-9418-C7BA6C4525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04604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23D421B-2D17-4A13-958E-CCDD4695E7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304BFCC-BDE4-4556-A3E8-87D74DEF516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1972B5B5-42CC-4E01-B963-90A531BD70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5C5E50CF-FC30-4D4D-B935-40E46C6B2E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6E50A-900A-42D8-9AC2-0BDD1A2E026D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808C3907-AEC7-454E-9014-3F7D52F66C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578DCF0-ADE3-4DC6-99B5-89C66305CD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E98E7-7B45-4A9A-9418-C7BA6C4525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05752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C045665-0F5A-43D9-B805-70B3F29339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131220D-2A8D-4FA2-A254-1CD2B620F9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91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1" indent="0">
              <a:buNone/>
              <a:defRPr sz="2000" b="1"/>
            </a:lvl2pPr>
            <a:lvl3pPr marL="914422" indent="0">
              <a:buNone/>
              <a:defRPr sz="1801" b="1"/>
            </a:lvl3pPr>
            <a:lvl4pPr marL="1371635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8" indent="0">
              <a:buNone/>
              <a:defRPr sz="1600" b="1"/>
            </a:lvl7pPr>
            <a:lvl8pPr marL="3200481" indent="0">
              <a:buNone/>
              <a:defRPr sz="1600" b="1"/>
            </a:lvl8pPr>
            <a:lvl9pPr marL="3657692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EE854096-20A3-4A22-97BC-1ECAB6ED00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91" y="2505076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8C14C2F7-FF80-45D3-A53D-8EEDCAC3507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3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1" indent="0">
              <a:buNone/>
              <a:defRPr sz="2000" b="1"/>
            </a:lvl2pPr>
            <a:lvl3pPr marL="914422" indent="0">
              <a:buNone/>
              <a:defRPr sz="1801" b="1"/>
            </a:lvl3pPr>
            <a:lvl4pPr marL="1371635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8" indent="0">
              <a:buNone/>
              <a:defRPr sz="1600" b="1"/>
            </a:lvl7pPr>
            <a:lvl8pPr marL="3200481" indent="0">
              <a:buNone/>
              <a:defRPr sz="1600" b="1"/>
            </a:lvl8pPr>
            <a:lvl9pPr marL="3657692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B0A29009-D777-480A-A405-EF95B68A44B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3" y="2505076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AD1DCB20-3D28-41E1-A8C6-6794E6D692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6E50A-900A-42D8-9AC2-0BDD1A2E026D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AF65A726-DF57-479C-B3A5-2D24F5DDCD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52465AF2-E3E7-49F1-BDDC-E70D30CA20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E98E7-7B45-4A9A-9418-C7BA6C4525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6705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A30D3E8-855C-4EED-9C67-09473A6F26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0EF2718C-78D2-4B02-9EA5-22C1B1F288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6E50A-900A-42D8-9AC2-0BDD1A2E026D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750318C9-60B9-44F1-A0C9-56B8C5A5B7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19916AC5-09CA-4D1B-946B-A30AAFDA5A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E98E7-7B45-4A9A-9418-C7BA6C4525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497286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9EF8A272-6208-414D-ABC6-521004F318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6E50A-900A-42D8-9AC2-0BDD1A2E026D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24820B9D-FB37-435F-9B81-3B6E650FA4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871C8675-F709-46D5-AFF3-5DF376CA97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E98E7-7B45-4A9A-9418-C7BA6C4525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80375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CCDAA62-7118-4008-ADF1-9BC718B32B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F4C205E-93A5-4414-8D55-38DB90BD1F6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90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06DA1D77-D33A-440B-BB42-ABB8B4B2EC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1" indent="0">
              <a:buNone/>
              <a:defRPr sz="1401"/>
            </a:lvl2pPr>
            <a:lvl3pPr marL="914422" indent="0">
              <a:buNone/>
              <a:defRPr sz="1200"/>
            </a:lvl3pPr>
            <a:lvl4pPr marL="1371635" indent="0">
              <a:buNone/>
              <a:defRPr sz="1001"/>
            </a:lvl4pPr>
            <a:lvl5pPr marL="1828846" indent="0">
              <a:buNone/>
              <a:defRPr sz="1001"/>
            </a:lvl5pPr>
            <a:lvl6pPr marL="2286057" indent="0">
              <a:buNone/>
              <a:defRPr sz="1001"/>
            </a:lvl6pPr>
            <a:lvl7pPr marL="2743268" indent="0">
              <a:buNone/>
              <a:defRPr sz="1001"/>
            </a:lvl7pPr>
            <a:lvl8pPr marL="3200481" indent="0">
              <a:buNone/>
              <a:defRPr sz="1001"/>
            </a:lvl8pPr>
            <a:lvl9pPr marL="3657692" indent="0">
              <a:buNone/>
              <a:defRPr sz="100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35737BB-9E65-44C3-9466-893F483580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6E50A-900A-42D8-9AC2-0BDD1A2E026D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1A32A99-571F-4A71-AF6D-0E0E82FDD7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D598CAF-BB0E-4A12-92F9-DB3A71169D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E98E7-7B45-4A9A-9418-C7BA6C4525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02991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58AB7AB-5857-42DB-984C-829E74298C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16FE9D92-7454-40FA-A10B-0CE423729C7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90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11" indent="0">
              <a:buNone/>
              <a:defRPr sz="2800"/>
            </a:lvl2pPr>
            <a:lvl3pPr marL="914422" indent="0">
              <a:buNone/>
              <a:defRPr sz="2400"/>
            </a:lvl3pPr>
            <a:lvl4pPr marL="1371635" indent="0">
              <a:buNone/>
              <a:defRPr sz="2000"/>
            </a:lvl4pPr>
            <a:lvl5pPr marL="1828846" indent="0">
              <a:buNone/>
              <a:defRPr sz="2000"/>
            </a:lvl5pPr>
            <a:lvl6pPr marL="2286057" indent="0">
              <a:buNone/>
              <a:defRPr sz="2000"/>
            </a:lvl6pPr>
            <a:lvl7pPr marL="2743268" indent="0">
              <a:buNone/>
              <a:defRPr sz="2000"/>
            </a:lvl7pPr>
            <a:lvl8pPr marL="3200481" indent="0">
              <a:buNone/>
              <a:defRPr sz="2000"/>
            </a:lvl8pPr>
            <a:lvl9pPr marL="3657692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93F309FE-2A14-44E6-8308-4A304993EF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1" indent="0">
              <a:buNone/>
              <a:defRPr sz="1401"/>
            </a:lvl2pPr>
            <a:lvl3pPr marL="914422" indent="0">
              <a:buNone/>
              <a:defRPr sz="1200"/>
            </a:lvl3pPr>
            <a:lvl4pPr marL="1371635" indent="0">
              <a:buNone/>
              <a:defRPr sz="1001"/>
            </a:lvl4pPr>
            <a:lvl5pPr marL="1828846" indent="0">
              <a:buNone/>
              <a:defRPr sz="1001"/>
            </a:lvl5pPr>
            <a:lvl6pPr marL="2286057" indent="0">
              <a:buNone/>
              <a:defRPr sz="1001"/>
            </a:lvl6pPr>
            <a:lvl7pPr marL="2743268" indent="0">
              <a:buNone/>
              <a:defRPr sz="1001"/>
            </a:lvl7pPr>
            <a:lvl8pPr marL="3200481" indent="0">
              <a:buNone/>
              <a:defRPr sz="1001"/>
            </a:lvl8pPr>
            <a:lvl9pPr marL="3657692" indent="0">
              <a:buNone/>
              <a:defRPr sz="100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626CE25E-5C49-43A5-9292-96D62C6F84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6E50A-900A-42D8-9AC2-0BDD1A2E026D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DFC173EF-A6A0-41E3-AD34-F5A7D3CF88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985B426-DCC7-48BB-8A03-26D64A264C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E98E7-7B45-4A9A-9418-C7BA6C4525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07864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CB74D768-8EB3-4677-9B5C-D9ADCE48D3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4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95EEAF48-67AA-4318-AF72-C11ABA0C5B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4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4CF760A-8D0A-49D7-AB39-7964CD1A225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D6E50A-900A-42D8-9AC2-0BDD1A2E026D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C87C99D-A55E-4BBE-B583-B9A1CF61ACA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4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6E91DD1-75DE-45DE-871E-C7E966C1B9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2E98E7-7B45-4A9A-9418-C7BA6C4525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35196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22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6" indent="-228606" algn="l" defTabSz="914422" rtl="0" eaLnBrk="1" latinLnBrk="1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17" indent="-228606" algn="l" defTabSz="914422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28" indent="-228606" algn="l" defTabSz="914422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40" indent="-228606" algn="l" defTabSz="914422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51" indent="-228606" algn="l" defTabSz="914422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64" indent="-228606" algn="l" defTabSz="914422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874" indent="-228606" algn="l" defTabSz="914422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086" indent="-228606" algn="l" defTabSz="914422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297" indent="-228606" algn="l" defTabSz="914422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22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11" algn="l" defTabSz="914422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22" algn="l" defTabSz="914422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35" algn="l" defTabSz="914422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46" algn="l" defTabSz="914422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057" algn="l" defTabSz="914422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268" algn="l" defTabSz="914422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481" algn="l" defTabSz="914422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692" algn="l" defTabSz="914422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4">
            <a:extLst>
              <a:ext uri="{FF2B5EF4-FFF2-40B4-BE49-F238E27FC236}">
                <a16:creationId xmlns:a16="http://schemas.microsoft.com/office/drawing/2014/main" id="{2A4996F3-4FE1-4B1F-8F64-B73BD21D5A40}"/>
              </a:ext>
            </a:extLst>
          </p:cNvPr>
          <p:cNvSpPr/>
          <p:nvPr/>
        </p:nvSpPr>
        <p:spPr>
          <a:xfrm>
            <a:off x="6450617" y="859020"/>
            <a:ext cx="5602837" cy="1070313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" name="직사각형 11">
            <a:extLst>
              <a:ext uri="{FF2B5EF4-FFF2-40B4-BE49-F238E27FC236}">
                <a16:creationId xmlns:a16="http://schemas.microsoft.com/office/drawing/2014/main" id="{A26B6440-74BF-4E7B-9D1D-23BBA8C77114}"/>
              </a:ext>
            </a:extLst>
          </p:cNvPr>
          <p:cNvSpPr/>
          <p:nvPr/>
        </p:nvSpPr>
        <p:spPr>
          <a:xfrm>
            <a:off x="138545" y="470785"/>
            <a:ext cx="6145820" cy="460131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EF91EF7-AADF-4B13-B3A1-0FC1CC2EFA51}"/>
              </a:ext>
            </a:extLst>
          </p:cNvPr>
          <p:cNvSpPr txBox="1"/>
          <p:nvPr/>
        </p:nvSpPr>
        <p:spPr>
          <a:xfrm>
            <a:off x="212435" y="505542"/>
            <a:ext cx="61458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/>
              <a:t>MRM-MS data (550 protein - 588 peptides)</a:t>
            </a:r>
            <a:endParaRPr lang="ko-KR" altLang="en-US" dirty="0"/>
          </a:p>
        </p:txBody>
      </p:sp>
      <p:sp>
        <p:nvSpPr>
          <p:cNvPr id="13" name="직사각형 12">
            <a:extLst>
              <a:ext uri="{FF2B5EF4-FFF2-40B4-BE49-F238E27FC236}">
                <a16:creationId xmlns:a16="http://schemas.microsoft.com/office/drawing/2014/main" id="{475234E7-F3A2-4FF8-AEA7-4D57F02C758C}"/>
              </a:ext>
            </a:extLst>
          </p:cNvPr>
          <p:cNvSpPr/>
          <p:nvPr/>
        </p:nvSpPr>
        <p:spPr>
          <a:xfrm>
            <a:off x="138545" y="1154328"/>
            <a:ext cx="6145821" cy="460131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>
                <a:solidFill>
                  <a:schemeClr val="tx1"/>
                </a:solidFill>
              </a:rPr>
              <a:t>Data preprocessing (420 proteins)</a:t>
            </a:r>
            <a:endParaRPr lang="ko-KR" altLang="en-US" dirty="0">
              <a:solidFill>
                <a:schemeClr val="tx1"/>
              </a:solidFill>
            </a:endParaRPr>
          </a:p>
        </p:txBody>
      </p:sp>
      <p:sp>
        <p:nvSpPr>
          <p:cNvPr id="14" name="직사각형 13">
            <a:extLst>
              <a:ext uri="{FF2B5EF4-FFF2-40B4-BE49-F238E27FC236}">
                <a16:creationId xmlns:a16="http://schemas.microsoft.com/office/drawing/2014/main" id="{4073D801-F4FA-46EF-A915-E83BB8EA3C68}"/>
              </a:ext>
            </a:extLst>
          </p:cNvPr>
          <p:cNvSpPr/>
          <p:nvPr/>
        </p:nvSpPr>
        <p:spPr>
          <a:xfrm>
            <a:off x="138544" y="1841520"/>
            <a:ext cx="6145821" cy="460131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>
                <a:solidFill>
                  <a:schemeClr val="tx1"/>
                </a:solidFill>
              </a:rPr>
              <a:t>Co-expression network </a:t>
            </a:r>
          </a:p>
        </p:txBody>
      </p:sp>
      <p:sp>
        <p:nvSpPr>
          <p:cNvPr id="16" name="화살표: 아래쪽 15">
            <a:extLst>
              <a:ext uri="{FF2B5EF4-FFF2-40B4-BE49-F238E27FC236}">
                <a16:creationId xmlns:a16="http://schemas.microsoft.com/office/drawing/2014/main" id="{6CDEABAC-D0F1-4C07-9F22-7D6C737041F5}"/>
              </a:ext>
            </a:extLst>
          </p:cNvPr>
          <p:cNvSpPr/>
          <p:nvPr/>
        </p:nvSpPr>
        <p:spPr>
          <a:xfrm>
            <a:off x="2925704" y="1618826"/>
            <a:ext cx="571500" cy="213434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직사각형 16">
            <a:extLst>
              <a:ext uri="{FF2B5EF4-FFF2-40B4-BE49-F238E27FC236}">
                <a16:creationId xmlns:a16="http://schemas.microsoft.com/office/drawing/2014/main" id="{BFE0C8C3-89B7-489B-913A-CE0C66E5AD71}"/>
              </a:ext>
            </a:extLst>
          </p:cNvPr>
          <p:cNvSpPr/>
          <p:nvPr/>
        </p:nvSpPr>
        <p:spPr>
          <a:xfrm>
            <a:off x="138544" y="2542700"/>
            <a:ext cx="6145822" cy="460131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>
                <a:solidFill>
                  <a:schemeClr val="tx1"/>
                </a:solidFill>
              </a:rPr>
              <a:t>Identify protein modules from network</a:t>
            </a:r>
          </a:p>
        </p:txBody>
      </p:sp>
      <p:sp>
        <p:nvSpPr>
          <p:cNvPr id="18" name="화살표: 아래쪽 17">
            <a:extLst>
              <a:ext uri="{FF2B5EF4-FFF2-40B4-BE49-F238E27FC236}">
                <a16:creationId xmlns:a16="http://schemas.microsoft.com/office/drawing/2014/main" id="{F4B60677-3A43-4524-9D0A-D0207F67B862}"/>
              </a:ext>
            </a:extLst>
          </p:cNvPr>
          <p:cNvSpPr/>
          <p:nvPr/>
        </p:nvSpPr>
        <p:spPr>
          <a:xfrm>
            <a:off x="2925704" y="2306185"/>
            <a:ext cx="571500" cy="213434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" name="화살표: 아래쪽 18">
            <a:extLst>
              <a:ext uri="{FF2B5EF4-FFF2-40B4-BE49-F238E27FC236}">
                <a16:creationId xmlns:a16="http://schemas.microsoft.com/office/drawing/2014/main" id="{B497CE41-D4BA-4C22-A70A-A09C91E03EDB}"/>
              </a:ext>
            </a:extLst>
          </p:cNvPr>
          <p:cNvSpPr/>
          <p:nvPr/>
        </p:nvSpPr>
        <p:spPr>
          <a:xfrm>
            <a:off x="2925704" y="3002306"/>
            <a:ext cx="571500" cy="213434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" name="직사각형 19">
            <a:extLst>
              <a:ext uri="{FF2B5EF4-FFF2-40B4-BE49-F238E27FC236}">
                <a16:creationId xmlns:a16="http://schemas.microsoft.com/office/drawing/2014/main" id="{09580B40-D162-4AD7-AF46-6443B0508956}"/>
              </a:ext>
            </a:extLst>
          </p:cNvPr>
          <p:cNvSpPr/>
          <p:nvPr/>
        </p:nvSpPr>
        <p:spPr>
          <a:xfrm>
            <a:off x="138544" y="3232895"/>
            <a:ext cx="6145822" cy="460131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>
                <a:solidFill>
                  <a:schemeClr val="tx1"/>
                </a:solidFill>
              </a:rPr>
              <a:t>Relate protein modules to demographic/clinical traits</a:t>
            </a:r>
            <a:endParaRPr lang="ko-KR" altLang="en-US" dirty="0">
              <a:solidFill>
                <a:schemeClr val="tx1"/>
              </a:solidFill>
            </a:endParaRPr>
          </a:p>
        </p:txBody>
      </p:sp>
      <p:sp>
        <p:nvSpPr>
          <p:cNvPr id="21" name="직사각형 20">
            <a:extLst>
              <a:ext uri="{FF2B5EF4-FFF2-40B4-BE49-F238E27FC236}">
                <a16:creationId xmlns:a16="http://schemas.microsoft.com/office/drawing/2014/main" id="{33F7E4A2-498F-44BC-9CCC-A193C02C6D22}"/>
              </a:ext>
            </a:extLst>
          </p:cNvPr>
          <p:cNvSpPr/>
          <p:nvPr/>
        </p:nvSpPr>
        <p:spPr>
          <a:xfrm>
            <a:off x="138543" y="3929786"/>
            <a:ext cx="6145822" cy="460131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>
                <a:solidFill>
                  <a:schemeClr val="tx1"/>
                </a:solidFill>
              </a:rPr>
              <a:t>Study module relationships with </a:t>
            </a:r>
            <a:r>
              <a:rPr lang="en-US" altLang="ko-KR" dirty="0" err="1">
                <a:solidFill>
                  <a:schemeClr val="tx1"/>
                </a:solidFill>
              </a:rPr>
              <a:t>eigenprotein</a:t>
            </a:r>
            <a:r>
              <a:rPr lang="en-US" altLang="ko-KR" dirty="0">
                <a:solidFill>
                  <a:schemeClr val="tx1"/>
                </a:solidFill>
              </a:rPr>
              <a:t> networks</a:t>
            </a:r>
            <a:endParaRPr lang="ko-KR" altLang="en-US" dirty="0">
              <a:solidFill>
                <a:schemeClr val="tx1"/>
              </a:solidFill>
            </a:endParaRPr>
          </a:p>
        </p:txBody>
      </p:sp>
      <p:sp>
        <p:nvSpPr>
          <p:cNvPr id="22" name="화살표: 아래쪽 21">
            <a:extLst>
              <a:ext uri="{FF2B5EF4-FFF2-40B4-BE49-F238E27FC236}">
                <a16:creationId xmlns:a16="http://schemas.microsoft.com/office/drawing/2014/main" id="{A8A314F9-D28C-4BD7-A939-91C136A66F5B}"/>
              </a:ext>
            </a:extLst>
          </p:cNvPr>
          <p:cNvSpPr/>
          <p:nvPr/>
        </p:nvSpPr>
        <p:spPr>
          <a:xfrm>
            <a:off x="2925704" y="3701341"/>
            <a:ext cx="571500" cy="213434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" name="화살표: 아래쪽 22">
            <a:extLst>
              <a:ext uri="{FF2B5EF4-FFF2-40B4-BE49-F238E27FC236}">
                <a16:creationId xmlns:a16="http://schemas.microsoft.com/office/drawing/2014/main" id="{CC458FD9-DB59-456B-83BA-5CA79D03FA0C}"/>
              </a:ext>
            </a:extLst>
          </p:cNvPr>
          <p:cNvSpPr/>
          <p:nvPr/>
        </p:nvSpPr>
        <p:spPr>
          <a:xfrm>
            <a:off x="2925704" y="4389917"/>
            <a:ext cx="571500" cy="213434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4" name="직사각형 23">
            <a:extLst>
              <a:ext uri="{FF2B5EF4-FFF2-40B4-BE49-F238E27FC236}">
                <a16:creationId xmlns:a16="http://schemas.microsoft.com/office/drawing/2014/main" id="{A726C277-DF22-41F4-ACC2-F895D0D2C732}"/>
              </a:ext>
            </a:extLst>
          </p:cNvPr>
          <p:cNvSpPr/>
          <p:nvPr/>
        </p:nvSpPr>
        <p:spPr>
          <a:xfrm>
            <a:off x="138543" y="4630342"/>
            <a:ext cx="6145822" cy="460131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>
                <a:solidFill>
                  <a:schemeClr val="tx1"/>
                </a:solidFill>
              </a:rPr>
              <a:t>Find hub proteins with interested modules</a:t>
            </a:r>
          </a:p>
        </p:txBody>
      </p:sp>
      <p:sp>
        <p:nvSpPr>
          <p:cNvPr id="25" name="직사각형 24">
            <a:extLst>
              <a:ext uri="{FF2B5EF4-FFF2-40B4-BE49-F238E27FC236}">
                <a16:creationId xmlns:a16="http://schemas.microsoft.com/office/drawing/2014/main" id="{5395DE14-F19E-4D2D-8DA7-9CF8AFF2B1BF}"/>
              </a:ext>
            </a:extLst>
          </p:cNvPr>
          <p:cNvSpPr/>
          <p:nvPr/>
        </p:nvSpPr>
        <p:spPr>
          <a:xfrm>
            <a:off x="138543" y="5321785"/>
            <a:ext cx="6145822" cy="460131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>
                <a:solidFill>
                  <a:schemeClr val="tx1"/>
                </a:solidFill>
              </a:rPr>
              <a:t>Functional (ontology) analysis with interested modules</a:t>
            </a:r>
          </a:p>
        </p:txBody>
      </p:sp>
      <p:sp>
        <p:nvSpPr>
          <p:cNvPr id="26" name="화살표: 아래쪽 25">
            <a:extLst>
              <a:ext uri="{FF2B5EF4-FFF2-40B4-BE49-F238E27FC236}">
                <a16:creationId xmlns:a16="http://schemas.microsoft.com/office/drawing/2014/main" id="{BBF8CC77-986C-4A74-A7D6-42A78FD6451A}"/>
              </a:ext>
            </a:extLst>
          </p:cNvPr>
          <p:cNvSpPr/>
          <p:nvPr/>
        </p:nvSpPr>
        <p:spPr>
          <a:xfrm>
            <a:off x="2925704" y="5090473"/>
            <a:ext cx="571500" cy="213434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832CF13-7576-427B-8193-8A9475F9BE63}"/>
              </a:ext>
            </a:extLst>
          </p:cNvPr>
          <p:cNvSpPr txBox="1"/>
          <p:nvPr/>
        </p:nvSpPr>
        <p:spPr>
          <a:xfrm>
            <a:off x="0" y="6242047"/>
            <a:ext cx="1138159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" panose="02020603050405020304" pitchFamily="18" charset="0"/>
                <a:cs typeface="TIMES" panose="02020603050405020304" pitchFamily="18" charset="0"/>
              </a:rPr>
              <a:t>Supplementary</a:t>
            </a:r>
            <a:r>
              <a:rPr lang="ko-KR" altLang="en-US" sz="1200" b="1" dirty="0">
                <a:latin typeface="TIMES" panose="02020603050405020304" pitchFamily="18" charset="0"/>
                <a:cs typeface="TIMES" panose="02020603050405020304" pitchFamily="18" charset="0"/>
              </a:rPr>
              <a:t> </a:t>
            </a:r>
            <a:r>
              <a:rPr lang="en-US" altLang="ko-KR" sz="1200" b="1" dirty="0">
                <a:latin typeface="TIMES" panose="02020603050405020304" pitchFamily="18" charset="0"/>
                <a:cs typeface="TIMES" panose="02020603050405020304" pitchFamily="18" charset="0"/>
              </a:rPr>
              <a:t>Figure</a:t>
            </a:r>
            <a:r>
              <a:rPr lang="ko-KR" altLang="en-US" sz="1200" b="1" dirty="0">
                <a:latin typeface="TIMES" panose="02020603050405020304" pitchFamily="18" charset="0"/>
                <a:cs typeface="TIMES" panose="02020603050405020304" pitchFamily="18" charset="0"/>
              </a:rPr>
              <a:t> </a:t>
            </a:r>
            <a:r>
              <a:rPr lang="en-US" altLang="ko-KR" sz="1200" b="1" dirty="0">
                <a:latin typeface="TIMES" panose="02020603050405020304" pitchFamily="18" charset="0"/>
                <a:cs typeface="TIMES" panose="02020603050405020304" pitchFamily="18" charset="0"/>
              </a:rPr>
              <a:t>1. Overview of the analysis</a:t>
            </a:r>
          </a:p>
          <a:p>
            <a:r>
              <a:rPr lang="en-US" altLang="ko-KR" sz="1200" dirty="0">
                <a:latin typeface="TIMES" panose="02020603050405020304" pitchFamily="18" charset="0"/>
                <a:cs typeface="TIMES" panose="02020603050405020304" pitchFamily="18" charset="0"/>
              </a:rPr>
              <a:t>This flowchart presents an overview of the steps of the weighted correlation network analysis</a:t>
            </a:r>
          </a:p>
          <a:p>
            <a:r>
              <a:rPr lang="en-US" altLang="ko-KR" sz="1200" dirty="0">
                <a:latin typeface="TIMES" panose="02020603050405020304" pitchFamily="18" charset="0"/>
                <a:cs typeface="TIMES" panose="02020603050405020304" pitchFamily="18" charset="0"/>
              </a:rPr>
              <a:t>Abbreviations : MRM; multiple reaction monitoring, MS; mass spectrometry, PAR; peak area ratio, BMI; body mass index </a:t>
            </a:r>
          </a:p>
          <a:p>
            <a:endParaRPr lang="ko-KR" alt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CB536A0-DF59-4A11-946C-D1C3D127261D}"/>
              </a:ext>
            </a:extLst>
          </p:cNvPr>
          <p:cNvSpPr txBox="1"/>
          <p:nvPr/>
        </p:nvSpPr>
        <p:spPr>
          <a:xfrm>
            <a:off x="6432146" y="859020"/>
            <a:ext cx="6014452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dirty="0"/>
              <a:t>1. Exclude low &amp; high PAR values (130 protein - 134 peptides) </a:t>
            </a:r>
          </a:p>
          <a:p>
            <a:r>
              <a:rPr lang="en-US" altLang="ko-KR" sz="1500" dirty="0"/>
              <a:t>2. Mean peptide PAR value for identical proteins (34 proteins)</a:t>
            </a:r>
          </a:p>
          <a:p>
            <a:r>
              <a:rPr lang="en-US" altLang="ko-KR" sz="1500" dirty="0"/>
              <a:t>3. Preparing batch correction by </a:t>
            </a:r>
            <a:r>
              <a:rPr lang="en-US" altLang="ko-KR" sz="1500" dirty="0" err="1"/>
              <a:t>ComBat</a:t>
            </a:r>
            <a:endParaRPr lang="en-US" altLang="ko-KR" sz="1500" dirty="0"/>
          </a:p>
          <a:p>
            <a:r>
              <a:rPr lang="en-US" altLang="ko-KR" sz="1500" dirty="0"/>
              <a:t>4. Regress out age, sex, and BMI by linear regression</a:t>
            </a:r>
          </a:p>
          <a:p>
            <a:endParaRPr lang="ko-KR" altLang="en-US" dirty="0"/>
          </a:p>
        </p:txBody>
      </p:sp>
      <p:sp>
        <p:nvSpPr>
          <p:cNvPr id="28" name="화살표: 아래쪽 27">
            <a:extLst>
              <a:ext uri="{FF2B5EF4-FFF2-40B4-BE49-F238E27FC236}">
                <a16:creationId xmlns:a16="http://schemas.microsoft.com/office/drawing/2014/main" id="{B62E355C-DF90-40B2-B9D1-2CC63E026B3B}"/>
              </a:ext>
            </a:extLst>
          </p:cNvPr>
          <p:cNvSpPr/>
          <p:nvPr/>
        </p:nvSpPr>
        <p:spPr>
          <a:xfrm>
            <a:off x="2925704" y="940894"/>
            <a:ext cx="571500" cy="213434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" name="왼쪽 중괄호 5">
            <a:extLst>
              <a:ext uri="{FF2B5EF4-FFF2-40B4-BE49-F238E27FC236}">
                <a16:creationId xmlns:a16="http://schemas.microsoft.com/office/drawing/2014/main" id="{E8EBE30A-9E87-414A-AA2E-80E2F3A462F8}"/>
              </a:ext>
            </a:extLst>
          </p:cNvPr>
          <p:cNvSpPr/>
          <p:nvPr/>
        </p:nvSpPr>
        <p:spPr>
          <a:xfrm>
            <a:off x="6294814" y="859020"/>
            <a:ext cx="145353" cy="1061992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9650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A2DF4FA4-6841-ABF8-1C39-54410B8E272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74827" y="952499"/>
            <a:ext cx="6953250" cy="495300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D874A2B-0010-FD84-3101-748820065866}"/>
              </a:ext>
            </a:extLst>
          </p:cNvPr>
          <p:cNvSpPr txBox="1"/>
          <p:nvPr/>
        </p:nvSpPr>
        <p:spPr>
          <a:xfrm>
            <a:off x="0" y="6304002"/>
            <a:ext cx="1138159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" panose="02020603050405020304" pitchFamily="18" charset="0"/>
                <a:cs typeface="TIMES" panose="02020603050405020304" pitchFamily="18" charset="0"/>
              </a:rPr>
              <a:t>Supplementary</a:t>
            </a:r>
            <a:r>
              <a:rPr lang="ko-KR" altLang="en-US" sz="1200" b="1" dirty="0">
                <a:latin typeface="TIMES" panose="02020603050405020304" pitchFamily="18" charset="0"/>
                <a:cs typeface="TIMES" panose="02020603050405020304" pitchFamily="18" charset="0"/>
              </a:rPr>
              <a:t> </a:t>
            </a:r>
            <a:r>
              <a:rPr lang="en-US" altLang="ko-KR" sz="1200" b="1" dirty="0">
                <a:latin typeface="TIMES" panose="02020603050405020304" pitchFamily="18" charset="0"/>
                <a:cs typeface="TIMES" panose="02020603050405020304" pitchFamily="18" charset="0"/>
              </a:rPr>
              <a:t>Figure</a:t>
            </a:r>
            <a:r>
              <a:rPr lang="ko-KR" altLang="en-US" sz="1200" b="1" dirty="0">
                <a:latin typeface="TIMES" panose="02020603050405020304" pitchFamily="18" charset="0"/>
                <a:cs typeface="TIMES" panose="02020603050405020304" pitchFamily="18" charset="0"/>
              </a:rPr>
              <a:t> </a:t>
            </a:r>
            <a:r>
              <a:rPr lang="en-US" altLang="ko-KR" sz="1200" b="1" dirty="0">
                <a:latin typeface="TIMES" panose="02020603050405020304" pitchFamily="18" charset="0"/>
                <a:cs typeface="TIMES" panose="02020603050405020304" pitchFamily="18" charset="0"/>
              </a:rPr>
              <a:t>2. Clustering of module </a:t>
            </a:r>
            <a:r>
              <a:rPr lang="en-US" altLang="ko-KR" sz="1200" b="1" dirty="0" err="1">
                <a:latin typeface="TIMES" panose="02020603050405020304" pitchFamily="18" charset="0"/>
                <a:cs typeface="TIMES" panose="02020603050405020304" pitchFamily="18" charset="0"/>
              </a:rPr>
              <a:t>eigenproteins</a:t>
            </a:r>
            <a:r>
              <a:rPr lang="en-US" altLang="ko-KR" sz="1200" b="1" dirty="0">
                <a:latin typeface="TIMES" panose="02020603050405020304" pitchFamily="18" charset="0"/>
                <a:cs typeface="TIMES" panose="02020603050405020304" pitchFamily="18" charset="0"/>
              </a:rPr>
              <a:t>.</a:t>
            </a:r>
          </a:p>
          <a:p>
            <a:r>
              <a:rPr lang="en-US" altLang="ko-KR" sz="1200" dirty="0">
                <a:latin typeface="TIMES" panose="02020603050405020304" pitchFamily="18" charset="0"/>
                <a:cs typeface="TIMES" panose="02020603050405020304" pitchFamily="18" charset="0"/>
              </a:rPr>
              <a:t>Clustering for the initial modules, with height as the y-axis, is presented. All of the module heights were over 0.25, so no modules were needed to be merged.</a:t>
            </a:r>
          </a:p>
          <a:p>
            <a:endParaRPr lang="ko-KR" alt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B5C630A-3324-6979-B5BC-91698B462B20}"/>
              </a:ext>
            </a:extLst>
          </p:cNvPr>
          <p:cNvSpPr txBox="1"/>
          <p:nvPr/>
        </p:nvSpPr>
        <p:spPr>
          <a:xfrm>
            <a:off x="4195482" y="812605"/>
            <a:ext cx="52497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TIMES" panose="02020603050405020304" pitchFamily="18" charset="0"/>
                <a:cs typeface="TIMES" panose="02020603050405020304" pitchFamily="18" charset="0"/>
              </a:rPr>
              <a:t>Clustering of module </a:t>
            </a:r>
            <a:r>
              <a:rPr lang="en-US" altLang="ko-KR" sz="1600" b="1" dirty="0" err="1">
                <a:latin typeface="TIMES" panose="02020603050405020304" pitchFamily="18" charset="0"/>
                <a:cs typeface="TIMES" panose="02020603050405020304" pitchFamily="18" charset="0"/>
              </a:rPr>
              <a:t>eigenproteins</a:t>
            </a:r>
            <a:endParaRPr lang="ko-KR" altLang="en-US" sz="16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6" name="사각형: 둥근 모서리 5">
            <a:extLst>
              <a:ext uri="{FF2B5EF4-FFF2-40B4-BE49-F238E27FC236}">
                <a16:creationId xmlns:a16="http://schemas.microsoft.com/office/drawing/2014/main" id="{BF9035FD-129F-820C-D0EC-3DAD6D1EB75A}"/>
              </a:ext>
            </a:extLst>
          </p:cNvPr>
          <p:cNvSpPr/>
          <p:nvPr/>
        </p:nvSpPr>
        <p:spPr>
          <a:xfrm>
            <a:off x="4195482" y="1106387"/>
            <a:ext cx="3076687" cy="398502"/>
          </a:xfrm>
          <a:prstGeom prst="round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86082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제목 3">
            <a:extLst>
              <a:ext uri="{FF2B5EF4-FFF2-40B4-BE49-F238E27FC236}">
                <a16:creationId xmlns:a16="http://schemas.microsoft.com/office/drawing/2014/main" id="{C04F7C46-C1FA-E55D-E55E-6AEEF9A79B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내용 개체 틀 4">
            <a:extLst>
              <a:ext uri="{FF2B5EF4-FFF2-40B4-BE49-F238E27FC236}">
                <a16:creationId xmlns:a16="http://schemas.microsoft.com/office/drawing/2014/main" id="{9AA50643-74B0-55AA-0151-52ED0B9CBAD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ko-KR" altLang="en-US"/>
          </a:p>
        </p:txBody>
      </p:sp>
      <p:pic>
        <p:nvPicPr>
          <p:cNvPr id="6" name="그림 5">
            <a:extLst>
              <a:ext uri="{FF2B5EF4-FFF2-40B4-BE49-F238E27FC236}">
                <a16:creationId xmlns:a16="http://schemas.microsoft.com/office/drawing/2014/main" id="{975441D8-CBEF-2ECA-A1B3-13DA8743D1A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8091"/>
            <a:ext cx="11962504" cy="676181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82868DF-9FF3-0ED4-8E64-82A2C2EC7283}"/>
              </a:ext>
            </a:extLst>
          </p:cNvPr>
          <p:cNvSpPr txBox="1"/>
          <p:nvPr/>
        </p:nvSpPr>
        <p:spPr>
          <a:xfrm>
            <a:off x="0" y="6424500"/>
            <a:ext cx="1219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" panose="02020603050405020304" pitchFamily="18" charset="0"/>
                <a:cs typeface="TIMES" panose="02020603050405020304" pitchFamily="18" charset="0"/>
              </a:rPr>
              <a:t>Supplementary Figure 3. Network stability analysis</a:t>
            </a:r>
          </a:p>
          <a:p>
            <a:r>
              <a:rPr lang="en-US" altLang="ko-KR" sz="1200" dirty="0">
                <a:latin typeface="TIMES" panose="02020603050405020304" pitchFamily="18" charset="0"/>
                <a:cs typeface="TIMES" panose="02020603050405020304" pitchFamily="18" charset="0"/>
              </a:rPr>
              <a:t>The modules of the full set (initial network, on top), followed by 100 repeated subsampling (63% of the final study population) are labeled colors to compare network stability.</a:t>
            </a:r>
            <a:endParaRPr lang="ko-KR" altLang="en-US" sz="12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22348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7</TotalTime>
  <Words>236</Words>
  <Application>Microsoft Office PowerPoint</Application>
  <PresentationFormat>와이드스크린</PresentationFormat>
  <Paragraphs>24</Paragraphs>
  <Slides>3</Slides>
  <Notes>3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7" baseType="lpstr">
      <vt:lpstr>맑은 고딕</vt:lpstr>
      <vt:lpstr>Arial</vt:lpstr>
      <vt:lpstr>TIMES</vt:lpstr>
      <vt:lpstr>Office 테마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Rhee</dc:creator>
  <cp:lastModifiedBy>Rhee</cp:lastModifiedBy>
  <cp:revision>41</cp:revision>
  <dcterms:created xsi:type="dcterms:W3CDTF">2022-07-11T03:48:29Z</dcterms:created>
  <dcterms:modified xsi:type="dcterms:W3CDTF">2023-04-14T02:03:06Z</dcterms:modified>
</cp:coreProperties>
</file>